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7"/>
  </p:notesMasterIdLst>
  <p:sldIdLst>
    <p:sldId id="390" r:id="rId2"/>
    <p:sldId id="441" r:id="rId3"/>
    <p:sldId id="388" r:id="rId4"/>
    <p:sldId id="426" r:id="rId5"/>
    <p:sldId id="427" r:id="rId6"/>
    <p:sldId id="428" r:id="rId7"/>
    <p:sldId id="429" r:id="rId8"/>
    <p:sldId id="430" r:id="rId9"/>
    <p:sldId id="431" r:id="rId10"/>
    <p:sldId id="432" r:id="rId11"/>
    <p:sldId id="433" r:id="rId12"/>
    <p:sldId id="434" r:id="rId13"/>
    <p:sldId id="435" r:id="rId14"/>
    <p:sldId id="436" r:id="rId15"/>
    <p:sldId id="437" r:id="rId16"/>
    <p:sldId id="438" r:id="rId17"/>
    <p:sldId id="439" r:id="rId18"/>
    <p:sldId id="405" r:id="rId19"/>
    <p:sldId id="406" r:id="rId20"/>
    <p:sldId id="408" r:id="rId21"/>
    <p:sldId id="409" r:id="rId22"/>
    <p:sldId id="412" r:id="rId23"/>
    <p:sldId id="413" r:id="rId24"/>
    <p:sldId id="416" r:id="rId25"/>
    <p:sldId id="417" r:id="rId26"/>
    <p:sldId id="420" r:id="rId27"/>
    <p:sldId id="440" r:id="rId28"/>
    <p:sldId id="407" r:id="rId29"/>
    <p:sldId id="410" r:id="rId30"/>
    <p:sldId id="411" r:id="rId31"/>
    <p:sldId id="414" r:id="rId32"/>
    <p:sldId id="415" r:id="rId33"/>
    <p:sldId id="418" r:id="rId34"/>
    <p:sldId id="419" r:id="rId35"/>
    <p:sldId id="421" r:id="rId36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273" autoAdjust="0"/>
  </p:normalViewPr>
  <p:slideViewPr>
    <p:cSldViewPr>
      <p:cViewPr varScale="1">
        <p:scale>
          <a:sx n="122" d="100"/>
          <a:sy n="122" d="100"/>
        </p:scale>
        <p:origin x="128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viewProps" Target="view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notesMaster" Target="notesMasters/notesMaster1.xml"/><Relationship Id="rId40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6354C0-BDEE-4FBC-BC40-BAEABA64CB94}" type="datetimeFigureOut">
              <a:rPr lang="en-GB" smtClean="0"/>
              <a:pPr/>
              <a:t>14/01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02CA9C-FF82-4EF6-B762-E6443EB870F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12613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36C07-7E76-46D3-B86B-6AF7C60E533E}" type="datetimeFigureOut">
              <a:rPr lang="nl-NL" smtClean="0"/>
              <a:pPr/>
              <a:t>14-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96D49-DAE3-40DE-93E0-41688E0A5016}" type="slidenum">
              <a:rPr lang="nl-NL" smtClean="0"/>
              <a:pPr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624" y="2636912"/>
            <a:ext cx="7028132" cy="374441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336074" y="1052736"/>
            <a:ext cx="473123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00" dirty="0" smtClean="0">
                <a:solidFill>
                  <a:srgbClr val="FF0000"/>
                </a:solidFill>
              </a:rPr>
              <a:t>SENSITIVITY ANALYSIS</a:t>
            </a:r>
            <a:endParaRPr lang="en-GB" sz="40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87014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4056" y="3068960"/>
            <a:ext cx="4991871" cy="37199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531566" y="0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695119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8300" y="2924944"/>
            <a:ext cx="5159207" cy="37917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537470" y="0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4967181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8282" y="2952054"/>
            <a:ext cx="5019243" cy="37404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20451" y="0"/>
            <a:ext cx="172354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6658088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3728" y="2952054"/>
            <a:ext cx="5140160" cy="38369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20451" y="0"/>
            <a:ext cx="172354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809174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1720" y="2952054"/>
            <a:ext cx="5206054" cy="38182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20451" y="0"/>
            <a:ext cx="172354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6727819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704" y="2859776"/>
            <a:ext cx="5298461" cy="39806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20451" y="0"/>
            <a:ext cx="172354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13962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5696" y="2915637"/>
            <a:ext cx="5238665" cy="39423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20451" y="0"/>
            <a:ext cx="172354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2583408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704" y="2877800"/>
            <a:ext cx="5312747" cy="39692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20451" y="0"/>
            <a:ext cx="172354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0020936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71800" y="2924944"/>
            <a:ext cx="374249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dirty="0" smtClean="0"/>
              <a:t>Sensitivity Analysis</a:t>
            </a:r>
          </a:p>
          <a:p>
            <a:pPr algn="ctr"/>
            <a:r>
              <a:rPr lang="en-GB" dirty="0" smtClean="0"/>
              <a:t>PARAMETER COMBINATION CHANGES</a:t>
            </a:r>
          </a:p>
          <a:p>
            <a:pPr algn="ctr"/>
            <a:r>
              <a:rPr lang="en-GB" dirty="0" smtClean="0">
                <a:solidFill>
                  <a:srgbClr val="FF0000"/>
                </a:solidFill>
              </a:rPr>
              <a:t>LEVELS +/- 5%</a:t>
            </a:r>
            <a:endParaRPr lang="en-GB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981400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0" y="6461913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4726" y="3245413"/>
            <a:ext cx="4061201" cy="30031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43825"/>
            <a:ext cx="4161559" cy="30046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9" name="Rectangle 8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03183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59832" y="3068960"/>
            <a:ext cx="3021981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dirty="0" smtClean="0"/>
              <a:t>Sensitivity Analysis</a:t>
            </a:r>
          </a:p>
          <a:p>
            <a:pPr algn="ctr"/>
            <a:r>
              <a:rPr lang="en-GB" dirty="0" smtClean="0"/>
              <a:t>SINGLE PARAMETER CHANGES</a:t>
            </a:r>
          </a:p>
          <a:p>
            <a:pPr algn="ctr"/>
            <a:r>
              <a:rPr lang="en-GB" dirty="0" smtClean="0">
                <a:solidFill>
                  <a:srgbClr val="FF0000"/>
                </a:solidFill>
              </a:rPr>
              <a:t>Levels: +/- 10%</a:t>
            </a:r>
            <a:endParaRPr lang="en-GB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575612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6510596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5" y="3247359"/>
            <a:ext cx="4108920" cy="30619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194" y="3233152"/>
            <a:ext cx="4176464" cy="30546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2500021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381328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4" y="3233150"/>
            <a:ext cx="4138559" cy="30761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496" y="3261248"/>
            <a:ext cx="4088495" cy="30480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8134536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444127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3" y="3257251"/>
            <a:ext cx="4145525" cy="30534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21870"/>
            <a:ext cx="4201918" cy="30888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Rectangle 8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10" name="Rectangle 9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5414448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381328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3" y="3233150"/>
            <a:ext cx="4087067" cy="30041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695" y="3223840"/>
            <a:ext cx="4173512" cy="31100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9935859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7504" y="6423153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3" y="3233149"/>
            <a:ext cx="4087067" cy="30639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843" y="3206613"/>
            <a:ext cx="4152086" cy="30905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7232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435250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3" y="3233150"/>
            <a:ext cx="4087067" cy="3012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33151"/>
            <a:ext cx="4174421" cy="30761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Rectangle 10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12" name="Rectangle 11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1694800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6488668"/>
            <a:ext cx="119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5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4" y="3233150"/>
            <a:ext cx="4098011" cy="30041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11215"/>
            <a:ext cx="4161559" cy="30881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3031107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71800" y="2924944"/>
            <a:ext cx="374249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dirty="0" smtClean="0"/>
              <a:t>Sensitivity Analysis</a:t>
            </a:r>
          </a:p>
          <a:p>
            <a:pPr algn="ctr"/>
            <a:r>
              <a:rPr lang="en-GB" dirty="0" smtClean="0"/>
              <a:t>PARAMETER COMBINATION CHANGES</a:t>
            </a:r>
          </a:p>
          <a:p>
            <a:pPr algn="ctr"/>
            <a:r>
              <a:rPr lang="en-GB" dirty="0" smtClean="0">
                <a:solidFill>
                  <a:srgbClr val="FF0000"/>
                </a:solidFill>
              </a:rPr>
              <a:t>LEVELS +/- 10%</a:t>
            </a:r>
            <a:endParaRPr lang="en-GB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356083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-3654" y="6381328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3" y="3233149"/>
            <a:ext cx="4319900" cy="31427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72083"/>
            <a:ext cx="4161559" cy="31038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600118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182651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5496" y="6381328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4" y="3233149"/>
            <a:ext cx="4087067" cy="30626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33150"/>
            <a:ext cx="4161559" cy="30619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05525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39552" y="188640"/>
            <a:ext cx="76613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ensitivity analysis: effect of individual parameter changes on GC response</a:t>
            </a:r>
          </a:p>
          <a:p>
            <a:endParaRPr lang="en-GB" sz="1400" dirty="0" smtClean="0"/>
          </a:p>
          <a:p>
            <a:r>
              <a:rPr lang="en-GB" sz="1400" dirty="0" err="1" smtClean="0"/>
              <a:t>Centroblast</a:t>
            </a:r>
            <a:r>
              <a:rPr lang="en-GB" sz="1400" dirty="0" smtClean="0"/>
              <a:t> (CB; blue), </a:t>
            </a:r>
            <a:r>
              <a:rPr lang="en-GB" sz="1400" dirty="0" err="1" smtClean="0"/>
              <a:t>c</a:t>
            </a:r>
            <a:r>
              <a:rPr lang="en-GB" sz="1400" dirty="0" err="1" smtClean="0"/>
              <a:t>entrocyte</a:t>
            </a:r>
            <a:r>
              <a:rPr lang="en-GB" sz="1400" dirty="0" smtClean="0"/>
              <a:t> </a:t>
            </a:r>
            <a:r>
              <a:rPr lang="en-GB" sz="1400" dirty="0" smtClean="0"/>
              <a:t>(CC; green), and total cell count (red).</a:t>
            </a:r>
          </a:p>
          <a:p>
            <a:endParaRPr lang="en-GB" sz="1400" dirty="0" smtClean="0"/>
          </a:p>
          <a:p>
            <a:r>
              <a:rPr lang="en-GB" sz="1400" dirty="0" smtClean="0"/>
              <a:t>For each of the 14 parameter changes a triple of CB, CC, and total cell counts was calculated. The </a:t>
            </a:r>
          </a:p>
          <a:p>
            <a:r>
              <a:rPr lang="en-GB" sz="1400" dirty="0" smtClean="0"/>
              <a:t>circles denote the mean counts obtained at the normal parameter levels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624" y="1700808"/>
            <a:ext cx="6117645" cy="40784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84064" y="6165304"/>
            <a:ext cx="86620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Note: in the next slides the individual curves are shown together with the correlation plots</a:t>
            </a:r>
          </a:p>
          <a:p>
            <a:r>
              <a:rPr lang="en-GB" dirty="0" smtClean="0"/>
              <a:t>and corresponding parameter.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7537470" y="-1736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5191133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3754" y="6394908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8148" y="3268531"/>
            <a:ext cx="4036300" cy="29921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33150"/>
            <a:ext cx="4161559" cy="31707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9454427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43531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8245" y="3224905"/>
            <a:ext cx="4083116" cy="30243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33151"/>
            <a:ext cx="4161559" cy="3082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6653334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988" y="6493925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3" y="3233150"/>
            <a:ext cx="4041345" cy="30761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32502"/>
            <a:ext cx="4161559" cy="30905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9587288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-51624" y="6443427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4" y="3253432"/>
            <a:ext cx="4083203" cy="29838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53432"/>
            <a:ext cx="4176464" cy="3072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60952620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43850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4" y="3284984"/>
            <a:ext cx="4042182" cy="29523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5953" y="3284984"/>
            <a:ext cx="4156858" cy="30660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3635249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5496" y="6488274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4294" y="3233150"/>
            <a:ext cx="4087067" cy="30849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7" y="3233150"/>
            <a:ext cx="4173788" cy="30849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5496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</a:t>
            </a:r>
            <a:r>
              <a:rPr lang="en-GB" b="1" dirty="0" smtClean="0"/>
              <a:t>changing five parameters simultaneously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4574294" y="1224279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0" name="Rectangle 9"/>
          <p:cNvSpPr/>
          <p:nvPr/>
        </p:nvSpPr>
        <p:spPr>
          <a:xfrm>
            <a:off x="260647" y="1224280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16 parameter changes a triple of CB, CC, and total cell counts was calculated. The circles denote the mean counts obtained at the normal parameter levels.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48694" y="789652"/>
            <a:ext cx="8427233" cy="289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each parameter combination, the sigmoi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ves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_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t there extreme valu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20451" y="0"/>
            <a:ext cx="17171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Comb1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089679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620688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620689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9672" y="2636912"/>
            <a:ext cx="5680709" cy="41498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7537470" y="-672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515769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736" y="2952054"/>
            <a:ext cx="5141336" cy="3789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478667" y="13895"/>
            <a:ext cx="1659429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 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80315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736" y="2952054"/>
            <a:ext cx="5163969" cy="37904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531566" y="0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334991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6186" y="2910814"/>
            <a:ext cx="5427612" cy="39267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537470" y="0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910649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5696" y="2924944"/>
            <a:ext cx="5253423" cy="38413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/>
          <p:cNvSpPr txBox="1"/>
          <p:nvPr/>
        </p:nvSpPr>
        <p:spPr>
          <a:xfrm>
            <a:off x="7537470" y="0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344355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496" y="116632"/>
            <a:ext cx="88569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ensitivity analysis: effect of individual parameter </a:t>
            </a:r>
            <a:r>
              <a:rPr lang="en-GB" b="1" dirty="0" smtClean="0"/>
              <a:t>changes</a:t>
            </a:r>
          </a:p>
          <a:p>
            <a:r>
              <a:rPr lang="en-GB" b="1" dirty="0" smtClean="0"/>
              <a:t> </a:t>
            </a:r>
            <a:endParaRPr lang="en-GB" dirty="0"/>
          </a:p>
        </p:txBody>
      </p:sp>
      <p:sp>
        <p:nvSpPr>
          <p:cNvPr id="5" name="Rectangle 4"/>
          <p:cNvSpPr/>
          <p:nvPr/>
        </p:nvSpPr>
        <p:spPr>
          <a:xfrm>
            <a:off x="4499992" y="925411"/>
            <a:ext cx="4087067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CORRELATION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 of CC cell counts and absolute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finity. </a:t>
            </a:r>
            <a:r>
              <a:rPr lang="en-US" sz="1200" dirty="0">
                <a:solidFill>
                  <a:srgbClr val="7030A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point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 a selection of subclones imposed on the density plot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rpl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indicate a selection of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lone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red line shows a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es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gression to indicate the overall relation between abundance and affinity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6" name="Rectangle 5"/>
          <p:cNvSpPr/>
          <p:nvPr/>
        </p:nvSpPr>
        <p:spPr>
          <a:xfrm>
            <a:off x="186345" y="925412"/>
            <a:ext cx="4161559" cy="18641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r>
              <a:rPr lang="en-GB" sz="1200" b="1" dirty="0" smtClean="0"/>
              <a:t>EFFECT ON GC response</a:t>
            </a:r>
          </a:p>
          <a:p>
            <a:r>
              <a:rPr lang="en-GB" sz="1200" dirty="0" err="1" smtClean="0"/>
              <a:t>Centroblast</a:t>
            </a:r>
            <a:r>
              <a:rPr lang="en-GB" sz="1200" dirty="0" smtClean="0"/>
              <a:t> </a:t>
            </a:r>
            <a:r>
              <a:rPr lang="en-GB" sz="1200" dirty="0"/>
              <a:t>(CB; </a:t>
            </a:r>
            <a:r>
              <a:rPr lang="en-GB" sz="1200" dirty="0" smtClean="0">
                <a:solidFill>
                  <a:srgbClr val="0000FF"/>
                </a:solidFill>
              </a:rPr>
              <a:t>blue</a:t>
            </a:r>
            <a:r>
              <a:rPr lang="en-GB" sz="1200" dirty="0" smtClean="0"/>
              <a:t>)</a:t>
            </a:r>
          </a:p>
          <a:p>
            <a:r>
              <a:rPr lang="en-GB" sz="1200" dirty="0" err="1" smtClean="0"/>
              <a:t>Centrocyte</a:t>
            </a:r>
            <a:r>
              <a:rPr lang="en-GB" sz="1200" dirty="0" smtClean="0"/>
              <a:t> </a:t>
            </a:r>
            <a:r>
              <a:rPr lang="en-GB" sz="1200" dirty="0"/>
              <a:t>(CC; </a:t>
            </a:r>
            <a:r>
              <a:rPr lang="en-GB" sz="1200" dirty="0">
                <a:solidFill>
                  <a:srgbClr val="00B050"/>
                </a:solidFill>
              </a:rPr>
              <a:t>green</a:t>
            </a:r>
            <a:r>
              <a:rPr lang="en-GB" sz="1200" dirty="0"/>
              <a:t>), </a:t>
            </a:r>
            <a:endParaRPr lang="en-GB" sz="1200" dirty="0" smtClean="0"/>
          </a:p>
          <a:p>
            <a:r>
              <a:rPr lang="en-GB" sz="1200" dirty="0" smtClean="0"/>
              <a:t>Total </a:t>
            </a:r>
            <a:r>
              <a:rPr lang="en-GB" sz="1200" dirty="0"/>
              <a:t>cell count (</a:t>
            </a:r>
            <a:r>
              <a:rPr lang="en-GB" sz="1200" dirty="0">
                <a:solidFill>
                  <a:srgbClr val="FF0000"/>
                </a:solidFill>
              </a:rPr>
              <a:t>red</a:t>
            </a:r>
            <a:r>
              <a:rPr lang="en-GB" sz="1200" dirty="0"/>
              <a:t>).</a:t>
            </a:r>
          </a:p>
          <a:p>
            <a:endParaRPr lang="en-GB" sz="1200" dirty="0"/>
          </a:p>
          <a:p>
            <a:r>
              <a:rPr lang="en-GB" sz="1200" dirty="0"/>
              <a:t>For each of the </a:t>
            </a:r>
            <a:r>
              <a:rPr lang="en-GB" sz="1200" dirty="0" smtClean="0"/>
              <a:t>14 parameter </a:t>
            </a:r>
            <a:r>
              <a:rPr lang="en-GB" sz="1200" dirty="0"/>
              <a:t>changes a triple of CB, CC, and total cell counts was calculated. The circles denote the mean counts obtained at the normal parameter level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6510596"/>
            <a:ext cx="1311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10% </a:t>
            </a:r>
            <a:r>
              <a:rPr lang="en-GB" dirty="0" smtClean="0">
                <a:solidFill>
                  <a:srgbClr val="0000FF"/>
                </a:solidFill>
              </a:rPr>
              <a:t>change</a:t>
            </a:r>
            <a:endParaRPr lang="en-GB" dirty="0">
              <a:solidFill>
                <a:srgbClr val="0000FF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5328" y="2852936"/>
            <a:ext cx="5293438" cy="38755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7537470" y="0"/>
            <a:ext cx="1606530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URE Single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66919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86</TotalTime>
  <Words>3987</Words>
  <Application>Microsoft Office PowerPoint</Application>
  <PresentationFormat>On-screen Show (4:3)</PresentationFormat>
  <Paragraphs>379</Paragraphs>
  <Slides>3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5</vt:i4>
      </vt:variant>
    </vt:vector>
  </HeadingPairs>
  <TitlesOfParts>
    <vt:vector size="39" baseType="lpstr">
      <vt:lpstr>Arial</vt:lpstr>
      <vt:lpstr>Calibri</vt:lpstr>
      <vt:lpstr>Times New Roman</vt:lpstr>
      <vt:lpstr>Office-th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K</dc:creator>
  <cp:lastModifiedBy>Antoine van Kampen</cp:lastModifiedBy>
  <cp:revision>242</cp:revision>
  <dcterms:created xsi:type="dcterms:W3CDTF">2016-01-20T15:28:15Z</dcterms:created>
  <dcterms:modified xsi:type="dcterms:W3CDTF">2017-01-14T10:49:32Z</dcterms:modified>
</cp:coreProperties>
</file>